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651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331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757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769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944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038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655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58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627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495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231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790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1E3C6-933F-4812-9601-F2AB407B4D50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CCDE7-8ACF-4DDF-912C-B408EA2F85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981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feld 13"/>
          <p:cNvSpPr txBox="1">
            <a:spLocks noChangeAspect="1"/>
          </p:cNvSpPr>
          <p:nvPr/>
        </p:nvSpPr>
        <p:spPr>
          <a:xfrm>
            <a:off x="8374" y="5562600"/>
            <a:ext cx="91356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0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erimental desig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arison SC/HF after 4, 12 and 24 weeks on diet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et intervention of the HF group after 4, 12 and 24 weeks on diet followed by SC for further 2, 4 and 12 weeks; n=6 for each diet and time point. Samples were collected as indicated by gray and black arrows. Data of the time points indicated by gray arrows not shown/discussed.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E55E40E3-2D02-40C7-9ED3-4603694ACBE5}"/>
              </a:ext>
            </a:extLst>
          </p:cNvPr>
          <p:cNvSpPr txBox="1"/>
          <p:nvPr/>
        </p:nvSpPr>
        <p:spPr>
          <a:xfrm>
            <a:off x="273767" y="985259"/>
            <a:ext cx="79303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8BAFE82C-C89D-4E03-AD08-56B8BC75EF51}"/>
              </a:ext>
            </a:extLst>
          </p:cNvPr>
          <p:cNvSpPr txBox="1"/>
          <p:nvPr/>
        </p:nvSpPr>
        <p:spPr>
          <a:xfrm>
            <a:off x="1062471" y="985256"/>
            <a:ext cx="2379098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Gerade Verbindung mit Pfeil 17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1062471" y="678013"/>
            <a:ext cx="0" cy="271577"/>
          </a:xfrm>
          <a:prstGeom prst="straightConnector1">
            <a:avLst/>
          </a:prstGeom>
          <a:ln w="28575">
            <a:solidFill>
              <a:srgbClr val="FF0000"/>
            </a:solidFill>
            <a:prstDash val="sysDot"/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feld 18">
            <a:extLst>
              <a:ext uri="{FF2B5EF4-FFF2-40B4-BE49-F238E27FC236}">
                <a16:creationId xmlns:a16="http://schemas.microsoft.com/office/drawing/2014/main" id="{E55E40E3-2D02-40C7-9ED3-4603694ACBE5}"/>
              </a:ext>
            </a:extLst>
          </p:cNvPr>
          <p:cNvSpPr txBox="1"/>
          <p:nvPr/>
        </p:nvSpPr>
        <p:spPr>
          <a:xfrm>
            <a:off x="273767" y="1277779"/>
            <a:ext cx="79303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8BAFE82C-C89D-4E03-AD08-56B8BC75EF51}"/>
              </a:ext>
            </a:extLst>
          </p:cNvPr>
          <p:cNvSpPr txBox="1"/>
          <p:nvPr/>
        </p:nvSpPr>
        <p:spPr>
          <a:xfrm>
            <a:off x="1062471" y="1277779"/>
            <a:ext cx="2379098" cy="24622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F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809722" y="185566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1464200" y="678013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1860716" y="678013"/>
            <a:ext cx="0" cy="271577"/>
          </a:xfrm>
          <a:prstGeom prst="straightConnector1">
            <a:avLst/>
          </a:prstGeom>
          <a:ln w="28575">
            <a:solidFill>
              <a:schemeClr val="bg1">
                <a:lumMod val="75000"/>
              </a:schemeClr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2257233" y="678013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3441570" y="678013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1286908" y="381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676400" y="381000"/>
            <a:ext cx="35458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1200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2079537" y="381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3282521" y="381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182022" y="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4449222" y="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Gerade Verbindung mit Pfeil 85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6572214" y="2060084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Textfeld 89"/>
          <p:cNvSpPr txBox="1"/>
          <p:nvPr/>
        </p:nvSpPr>
        <p:spPr>
          <a:xfrm>
            <a:off x="6375400" y="17956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E55E40E3-2D02-40C7-9ED3-4603694ACBE5}"/>
              </a:ext>
            </a:extLst>
          </p:cNvPr>
          <p:cNvSpPr txBox="1"/>
          <p:nvPr/>
        </p:nvSpPr>
        <p:spPr>
          <a:xfrm>
            <a:off x="4571998" y="2380203"/>
            <a:ext cx="79303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E7F315FC-46DB-4F67-B4F4-2A7AAD0E6EE0}"/>
              </a:ext>
            </a:extLst>
          </p:cNvPr>
          <p:cNvSpPr txBox="1"/>
          <p:nvPr/>
        </p:nvSpPr>
        <p:spPr>
          <a:xfrm>
            <a:off x="5365030" y="2380203"/>
            <a:ext cx="239683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Gerade Verbindung mit Pfeil 66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6754615" y="2060087"/>
            <a:ext cx="0" cy="271577"/>
          </a:xfrm>
          <a:prstGeom prst="straightConnector1">
            <a:avLst/>
          </a:prstGeom>
          <a:ln w="28575">
            <a:solidFill>
              <a:schemeClr val="bg1">
                <a:lumMod val="75000"/>
              </a:schemeClr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Textfeld 67"/>
          <p:cNvSpPr txBox="1"/>
          <p:nvPr/>
        </p:nvSpPr>
        <p:spPr>
          <a:xfrm>
            <a:off x="6583365" y="17956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en-US" sz="1200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Gerade Verbindung mit Pfeil 68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6949572" y="2060087"/>
            <a:ext cx="0" cy="271577"/>
          </a:xfrm>
          <a:prstGeom prst="straightConnector1">
            <a:avLst/>
          </a:prstGeom>
          <a:ln w="28575">
            <a:solidFill>
              <a:schemeClr val="bg1">
                <a:lumMod val="75000"/>
              </a:schemeClr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feld 69"/>
          <p:cNvSpPr txBox="1"/>
          <p:nvPr/>
        </p:nvSpPr>
        <p:spPr>
          <a:xfrm>
            <a:off x="6791330" y="17956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en-US" sz="1200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Gerade Verbindung mit Pfeil 70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7761866" y="2060087"/>
            <a:ext cx="0" cy="271577"/>
          </a:xfrm>
          <a:prstGeom prst="straightConnector1">
            <a:avLst/>
          </a:prstGeom>
          <a:ln w="28575">
            <a:solidFill>
              <a:schemeClr val="bg1">
                <a:lumMod val="75000"/>
              </a:schemeClr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feld 71"/>
          <p:cNvSpPr txBox="1"/>
          <p:nvPr/>
        </p:nvSpPr>
        <p:spPr>
          <a:xfrm>
            <a:off x="7584574" y="17956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en-US" sz="1200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E55E40E3-2D02-40C7-9ED3-4603694ACBE5}"/>
              </a:ext>
            </a:extLst>
          </p:cNvPr>
          <p:cNvSpPr txBox="1"/>
          <p:nvPr/>
        </p:nvSpPr>
        <p:spPr>
          <a:xfrm>
            <a:off x="4571998" y="2669287"/>
            <a:ext cx="79303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8BAFE82C-C89D-4E03-AD08-56B8BC75EF51}"/>
              </a:ext>
            </a:extLst>
          </p:cNvPr>
          <p:cNvSpPr txBox="1">
            <a:spLocks/>
          </p:cNvSpPr>
          <p:nvPr/>
        </p:nvSpPr>
        <p:spPr>
          <a:xfrm>
            <a:off x="5370096" y="2669286"/>
            <a:ext cx="1188149" cy="24622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F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E7F315FC-46DB-4F67-B4F4-2A7AAD0E6EE0}"/>
              </a:ext>
            </a:extLst>
          </p:cNvPr>
          <p:cNvSpPr txBox="1"/>
          <p:nvPr/>
        </p:nvSpPr>
        <p:spPr>
          <a:xfrm>
            <a:off x="6564473" y="2669286"/>
            <a:ext cx="1197392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Gerade Verbindung mit Pfeil 75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5365030" y="2060087"/>
            <a:ext cx="0" cy="271577"/>
          </a:xfrm>
          <a:prstGeom prst="straightConnector1">
            <a:avLst/>
          </a:prstGeom>
          <a:ln w="28575">
            <a:solidFill>
              <a:srgbClr val="FF0000"/>
            </a:solidFill>
            <a:prstDash val="sysDot"/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mit Pfeil 86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7744131" y="3472098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Textfeld 90"/>
          <p:cNvSpPr txBox="1"/>
          <p:nvPr/>
        </p:nvSpPr>
        <p:spPr>
          <a:xfrm>
            <a:off x="7535089" y="32066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E7F315FC-46DB-4F67-B4F4-2A7AAD0E6EE0}"/>
              </a:ext>
            </a:extLst>
          </p:cNvPr>
          <p:cNvSpPr txBox="1"/>
          <p:nvPr/>
        </p:nvSpPr>
        <p:spPr>
          <a:xfrm>
            <a:off x="5365032" y="3800091"/>
            <a:ext cx="359351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7943069" y="3472101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/>
        </p:nvSpPr>
        <p:spPr>
          <a:xfrm>
            <a:off x="7754261" y="32066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Gerade Verbindung mit Pfeil 39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8138025" y="3472101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feld 40"/>
          <p:cNvSpPr txBox="1"/>
          <p:nvPr/>
        </p:nvSpPr>
        <p:spPr>
          <a:xfrm>
            <a:off x="7973433" y="32066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8958547" y="3472101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feld 42"/>
          <p:cNvSpPr txBox="1"/>
          <p:nvPr/>
        </p:nvSpPr>
        <p:spPr>
          <a:xfrm>
            <a:off x="8781255" y="32066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E55E40E3-2D02-40C7-9ED3-4603694ACBE5}"/>
              </a:ext>
            </a:extLst>
          </p:cNvPr>
          <p:cNvSpPr txBox="1"/>
          <p:nvPr/>
        </p:nvSpPr>
        <p:spPr>
          <a:xfrm>
            <a:off x="4572000" y="4097175"/>
            <a:ext cx="79303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8BAFE82C-C89D-4E03-AD08-56B8BC75EF51}"/>
              </a:ext>
            </a:extLst>
          </p:cNvPr>
          <p:cNvSpPr txBox="1">
            <a:spLocks/>
          </p:cNvSpPr>
          <p:nvPr/>
        </p:nvSpPr>
        <p:spPr>
          <a:xfrm>
            <a:off x="5365032" y="4097179"/>
            <a:ext cx="2394635" cy="24622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F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E7F315FC-46DB-4F67-B4F4-2A7AAD0E6EE0}"/>
              </a:ext>
            </a:extLst>
          </p:cNvPr>
          <p:cNvSpPr txBox="1"/>
          <p:nvPr/>
        </p:nvSpPr>
        <p:spPr>
          <a:xfrm>
            <a:off x="7761155" y="4097177"/>
            <a:ext cx="1197392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E55E40E3-2D02-40C7-9ED3-4603694ACBE5}"/>
              </a:ext>
            </a:extLst>
          </p:cNvPr>
          <p:cNvSpPr txBox="1"/>
          <p:nvPr/>
        </p:nvSpPr>
        <p:spPr>
          <a:xfrm>
            <a:off x="4572000" y="3800094"/>
            <a:ext cx="79303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Gerade Verbindung mit Pfeil 47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5365032" y="3472100"/>
            <a:ext cx="0" cy="271577"/>
          </a:xfrm>
          <a:prstGeom prst="straightConnector1">
            <a:avLst/>
          </a:prstGeom>
          <a:ln w="28575">
            <a:solidFill>
              <a:srgbClr val="FF0000"/>
            </a:solidFill>
            <a:prstDash val="sysDot"/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feld 50">
            <a:extLst>
              <a:ext uri="{FF2B5EF4-FFF2-40B4-BE49-F238E27FC236}">
                <a16:creationId xmlns:a16="http://schemas.microsoft.com/office/drawing/2014/main" id="{E55E40E3-2D02-40C7-9ED3-4603694ACBE5}"/>
              </a:ext>
            </a:extLst>
          </p:cNvPr>
          <p:cNvSpPr txBox="1"/>
          <p:nvPr/>
        </p:nvSpPr>
        <p:spPr>
          <a:xfrm>
            <a:off x="4572000" y="1285491"/>
            <a:ext cx="79303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8BAFE82C-C89D-4E03-AD08-56B8BC75EF51}"/>
              </a:ext>
            </a:extLst>
          </p:cNvPr>
          <p:cNvSpPr txBox="1"/>
          <p:nvPr/>
        </p:nvSpPr>
        <p:spPr>
          <a:xfrm>
            <a:off x="5362571" y="992883"/>
            <a:ext cx="156905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E55E40E3-2D02-40C7-9ED3-4603694ACBE5}"/>
              </a:ext>
            </a:extLst>
          </p:cNvPr>
          <p:cNvSpPr txBox="1"/>
          <p:nvPr/>
        </p:nvSpPr>
        <p:spPr>
          <a:xfrm>
            <a:off x="4572000" y="992883"/>
            <a:ext cx="793033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E7F315FC-46DB-4F67-B4F4-2A7AAD0E6EE0}"/>
              </a:ext>
            </a:extLst>
          </p:cNvPr>
          <p:cNvSpPr txBox="1"/>
          <p:nvPr/>
        </p:nvSpPr>
        <p:spPr>
          <a:xfrm>
            <a:off x="5734233" y="1285491"/>
            <a:ext cx="1197391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Gerade Verbindung mit Pfeil 54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5943637" y="685920"/>
            <a:ext cx="0" cy="271577"/>
          </a:xfrm>
          <a:prstGeom prst="straightConnector1">
            <a:avLst/>
          </a:prstGeom>
          <a:ln w="28575">
            <a:solidFill>
              <a:schemeClr val="bg1">
                <a:lumMod val="75000"/>
              </a:schemeClr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5766308" y="381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1200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Gerade Verbindung mit Pfeil 56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6138593" y="685920"/>
            <a:ext cx="0" cy="271577"/>
          </a:xfrm>
          <a:prstGeom prst="straightConnector1">
            <a:avLst/>
          </a:prstGeom>
          <a:ln w="28575">
            <a:solidFill>
              <a:schemeClr val="bg1">
                <a:lumMod val="75000"/>
              </a:schemeClr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Textfeld 57"/>
          <p:cNvSpPr txBox="1"/>
          <p:nvPr/>
        </p:nvSpPr>
        <p:spPr>
          <a:xfrm>
            <a:off x="5970016" y="381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1200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Gerade Verbindung mit Pfeil 58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6934085" y="685920"/>
            <a:ext cx="0" cy="271577"/>
          </a:xfrm>
          <a:prstGeom prst="straightConnector1">
            <a:avLst/>
          </a:prstGeom>
          <a:ln w="28575">
            <a:solidFill>
              <a:schemeClr val="bg1">
                <a:lumMod val="75000"/>
              </a:schemeClr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Textfeld 59"/>
          <p:cNvSpPr txBox="1"/>
          <p:nvPr/>
        </p:nvSpPr>
        <p:spPr>
          <a:xfrm>
            <a:off x="6756400" y="381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en-US" sz="1200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Gerade Verbindung mit Pfeil 60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5365032" y="685922"/>
            <a:ext cx="0" cy="271577"/>
          </a:xfrm>
          <a:prstGeom prst="straightConnector1">
            <a:avLst/>
          </a:prstGeom>
          <a:ln w="28575">
            <a:solidFill>
              <a:srgbClr val="FF0000"/>
            </a:solidFill>
            <a:prstDash val="sysDot"/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feld 61"/>
          <p:cNvSpPr txBox="1"/>
          <p:nvPr/>
        </p:nvSpPr>
        <p:spPr>
          <a:xfrm>
            <a:off x="5106282" y="185566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8BAFE82C-C89D-4E03-AD08-56B8BC75EF51}"/>
              </a:ext>
            </a:extLst>
          </p:cNvPr>
          <p:cNvSpPr txBox="1">
            <a:spLocks/>
          </p:cNvSpPr>
          <p:nvPr/>
        </p:nvSpPr>
        <p:spPr>
          <a:xfrm>
            <a:off x="5365032" y="1285492"/>
            <a:ext cx="393787" cy="24622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F</a:t>
            </a:r>
            <a:endParaRPr lang="en-US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Gerade Verbindung mit Pfeil 102">
            <a:extLst>
              <a:ext uri="{FF2B5EF4-FFF2-40B4-BE49-F238E27FC236}">
                <a16:creationId xmlns:a16="http://schemas.microsoft.com/office/drawing/2014/main" id="{7FC14AC7-16F2-4136-84BD-4B73646E69F6}"/>
              </a:ext>
            </a:extLst>
          </p:cNvPr>
          <p:cNvCxnSpPr>
            <a:cxnSpLocks noChangeAspect="1"/>
          </p:cNvCxnSpPr>
          <p:nvPr/>
        </p:nvCxnSpPr>
        <p:spPr>
          <a:xfrm>
            <a:off x="5756043" y="685913"/>
            <a:ext cx="0" cy="2715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5562600" y="381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273767" y="401014"/>
            <a:ext cx="66236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[weeks]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930524" y="3810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4560017" y="401014"/>
            <a:ext cx="66236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[weeks]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5237728" y="3810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82" name="Textfeld 81"/>
          <p:cNvSpPr txBox="1"/>
          <p:nvPr/>
        </p:nvSpPr>
        <p:spPr>
          <a:xfrm>
            <a:off x="5118265" y="1600200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4572000" y="1815648"/>
            <a:ext cx="66236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[weeks]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5237728" y="179563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5118265" y="3011265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4572000" y="3226713"/>
            <a:ext cx="66236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[weeks]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5237728" y="320669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210615231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2</Words>
  <Application>Microsoft Office PowerPoint</Application>
  <PresentationFormat>Bildschirmpräsentation 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24</cp:revision>
  <dcterms:created xsi:type="dcterms:W3CDTF">2020-03-25T14:24:18Z</dcterms:created>
  <dcterms:modified xsi:type="dcterms:W3CDTF">2021-09-21T13:01:01Z</dcterms:modified>
</cp:coreProperties>
</file>